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516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user\Desktop\Mateusz\Projekty\PLC\Chemotaksja%20GR-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7308211736484781"/>
          <c:y val="0.15510861790811351"/>
          <c:w val="0.59373540453794582"/>
          <c:h val="0.757818303846046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ACS (GR-1)'!$B$2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tx1">
                  <a:lumMod val="75000"/>
                  <a:lumOff val="25000"/>
                </a:schemeClr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ACS (GR-1)'!$B$17:$D$1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FACS (GR-1)'!$B$17:$D$1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'FACS (GR-1)'!$B$3:$D$3</c:f>
              <c:strCache>
                <c:ptCount val="3"/>
                <c:pt idx="0">
                  <c:v>SDF-1</c:v>
                </c:pt>
                <c:pt idx="1">
                  <c:v>RANTES</c:v>
                </c:pt>
                <c:pt idx="2">
                  <c:v>MIP-1α</c:v>
                </c:pt>
              </c:strCache>
            </c:strRef>
          </c:cat>
          <c:val>
            <c:numRef>
              <c:f>'FACS (GR-1)'!$B$16:$D$16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FACS (GR-1)'!$F$2</c:f>
              <c:strCache>
                <c:ptCount val="1"/>
                <c:pt idx="0">
                  <c:v>PLCβ2-KO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ACS (GR-1)'!$F$18:$H$18</c:f>
                <c:numCache>
                  <c:formatCode>General</c:formatCode>
                  <c:ptCount val="3"/>
                  <c:pt idx="0">
                    <c:v>8.379024620490819</c:v>
                  </c:pt>
                  <c:pt idx="1">
                    <c:v>6.1007347926499458</c:v>
                  </c:pt>
                  <c:pt idx="2">
                    <c:v>13.864253696451375</c:v>
                  </c:pt>
                </c:numCache>
              </c:numRef>
            </c:plus>
            <c:minus>
              <c:numRef>
                <c:f>'FACS (GR-1)'!$F$18:$H$18</c:f>
                <c:numCache>
                  <c:formatCode>General</c:formatCode>
                  <c:ptCount val="3"/>
                  <c:pt idx="0">
                    <c:v>8.379024620490819</c:v>
                  </c:pt>
                  <c:pt idx="1">
                    <c:v>6.1007347926499458</c:v>
                  </c:pt>
                  <c:pt idx="2">
                    <c:v>13.864253696451375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FACS (GR-1)'!$B$3:$D$3</c:f>
              <c:strCache>
                <c:ptCount val="3"/>
                <c:pt idx="0">
                  <c:v>SDF-1</c:v>
                </c:pt>
                <c:pt idx="1">
                  <c:v>RANTES</c:v>
                </c:pt>
                <c:pt idx="2">
                  <c:v>MIP-1α</c:v>
                </c:pt>
              </c:strCache>
            </c:strRef>
          </c:cat>
          <c:val>
            <c:numRef>
              <c:f>'FACS (GR-1)'!$F$17:$H$17</c:f>
              <c:numCache>
                <c:formatCode>General</c:formatCode>
                <c:ptCount val="3"/>
                <c:pt idx="0">
                  <c:v>71.323744514629453</c:v>
                </c:pt>
                <c:pt idx="1">
                  <c:v>41.61616673558693</c:v>
                </c:pt>
                <c:pt idx="2">
                  <c:v>53.272433907301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454336"/>
        <c:axId val="31455872"/>
      </c:barChart>
      <c:catAx>
        <c:axId val="3145433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455872"/>
        <c:crosses val="autoZero"/>
        <c:auto val="1"/>
        <c:lblAlgn val="ctr"/>
        <c:lblOffset val="100"/>
        <c:noMultiLvlLbl val="0"/>
      </c:catAx>
      <c:valAx>
        <c:axId val="31455872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45433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9.9062942793884362E-2"/>
          <c:y val="2.7241767468753599E-2"/>
          <c:w val="0.41170692540533088"/>
          <c:h val="6.9372602790005067E-2"/>
        </c:manualLayout>
      </c:layout>
      <c:overlay val="0"/>
      <c:spPr>
        <a:ln w="19050">
          <a:solidFill>
            <a:schemeClr val="tx1"/>
          </a:solidFill>
        </a:ln>
      </c:spPr>
      <c:txPr>
        <a:bodyPr/>
        <a:lstStyle/>
        <a:p>
          <a:pPr>
            <a:defRPr lang="en-US" sz="1400" b="1" i="0" u="none" strike="noStrike" kern="1200" baseline="0">
              <a:solidFill>
                <a:prstClr val="black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242326223306593"/>
          <c:y val="4.2354488299128842E-2"/>
          <c:w val="0.71454074402671497"/>
          <c:h val="0.858789690082840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ACS (All)'!$B$2</c:f>
              <c:strCache>
                <c:ptCount val="1"/>
                <c:pt idx="0">
                  <c:v>WT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tx1">
                  <a:lumMod val="75000"/>
                  <a:lumOff val="25000"/>
                </a:schemeClr>
              </a:bgClr>
            </a:pattFill>
            <a:ln w="19050"/>
          </c:spPr>
          <c:invertIfNegative val="0"/>
          <c:errBars>
            <c:errBarType val="plus"/>
            <c:errValType val="cust"/>
            <c:noEndCap val="0"/>
            <c:plus>
              <c:numRef>
                <c:f>'FACS (All)'!$B$17:$D$1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'FACS (All)'!$B$17:$D$1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</c:errBars>
          <c:cat>
            <c:strRef>
              <c:f>'FACS (All)'!$B$3:$D$3</c:f>
              <c:strCache>
                <c:ptCount val="3"/>
                <c:pt idx="0">
                  <c:v>SDF-1</c:v>
                </c:pt>
                <c:pt idx="1">
                  <c:v>RANTES</c:v>
                </c:pt>
                <c:pt idx="2">
                  <c:v>MIP-1α</c:v>
                </c:pt>
              </c:strCache>
            </c:strRef>
          </c:cat>
          <c:val>
            <c:numRef>
              <c:f>'FACS (All)'!$B$16:$D$16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FACS (All)'!$F$2</c:f>
              <c:strCache>
                <c:ptCount val="1"/>
                <c:pt idx="0">
                  <c:v>PLCβ2-KO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FACS (All)'!$F$18:$H$18</c:f>
                <c:numCache>
                  <c:formatCode>General</c:formatCode>
                  <c:ptCount val="3"/>
                  <c:pt idx="0">
                    <c:v>9.1835547418078978</c:v>
                  </c:pt>
                  <c:pt idx="1">
                    <c:v>5.0827732184948422</c:v>
                  </c:pt>
                  <c:pt idx="2">
                    <c:v>14.6432590812569</c:v>
                  </c:pt>
                </c:numCache>
              </c:numRef>
            </c:plus>
            <c:minus>
              <c:numRef>
                <c:f>'FACS (All)'!$F$18:$H$18</c:f>
                <c:numCache>
                  <c:formatCode>General</c:formatCode>
                  <c:ptCount val="3"/>
                  <c:pt idx="0">
                    <c:v>9.1835547418078978</c:v>
                  </c:pt>
                  <c:pt idx="1">
                    <c:v>5.0827732184948422</c:v>
                  </c:pt>
                  <c:pt idx="2">
                    <c:v>14.6432590812569</c:v>
                  </c:pt>
                </c:numCache>
              </c:numRef>
            </c:minus>
            <c:spPr>
              <a:ln w="19050" cap="sq"/>
            </c:spPr>
          </c:errBars>
          <c:cat>
            <c:strRef>
              <c:f>'FACS (All)'!$B$3:$D$3</c:f>
              <c:strCache>
                <c:ptCount val="3"/>
                <c:pt idx="0">
                  <c:v>SDF-1</c:v>
                </c:pt>
                <c:pt idx="1">
                  <c:v>RANTES</c:v>
                </c:pt>
                <c:pt idx="2">
                  <c:v>MIP-1α</c:v>
                </c:pt>
              </c:strCache>
            </c:strRef>
          </c:cat>
          <c:val>
            <c:numRef>
              <c:f>'FACS (All)'!$F$17:$H$17</c:f>
              <c:numCache>
                <c:formatCode>General</c:formatCode>
                <c:ptCount val="3"/>
                <c:pt idx="0">
                  <c:v>76.612719441310844</c:v>
                </c:pt>
                <c:pt idx="1">
                  <c:v>56.447937086958561</c:v>
                </c:pt>
                <c:pt idx="2">
                  <c:v>63.586027348644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763328"/>
        <c:axId val="33764864"/>
      </c:barChart>
      <c:catAx>
        <c:axId val="3376332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 algn="ctr">
              <a:defRPr lang="en-US"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764864"/>
        <c:crosses val="autoZero"/>
        <c:auto val="1"/>
        <c:lblAlgn val="ctr"/>
        <c:lblOffset val="100"/>
        <c:noMultiLvlLbl val="0"/>
      </c:catAx>
      <c:valAx>
        <c:axId val="33764864"/>
        <c:scaling>
          <c:orientation val="minMax"/>
          <c:max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% </a:t>
                </a:r>
                <a:r>
                  <a:rPr lang="en-US" sz="1400" smtClean="0"/>
                  <a:t>o</a:t>
                </a:r>
                <a:r>
                  <a:rPr lang="pl-PL" sz="1400" smtClean="0"/>
                  <a:t>f</a:t>
                </a:r>
                <a:r>
                  <a:rPr lang="en-US" sz="1400" smtClean="0"/>
                  <a:t> </a:t>
                </a:r>
                <a:r>
                  <a:rPr lang="pl-PL" sz="1400" smtClean="0"/>
                  <a:t>WT</a:t>
                </a:r>
                <a:endParaRPr lang="en-US" sz="140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33763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 algn="ctr">
        <a:defRPr lang="en-US" sz="1200" b="1" i="0" u="none" strike="noStrike" kern="1200" baseline="0">
          <a:solidFill>
            <a:prstClr val="black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321BF2-2B05-4BC3-BE06-DEE74763FF85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B4512C-2645-4E8A-95A3-1658AC9401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5451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64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351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097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33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642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409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078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949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896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1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651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B4DDB-657A-41A9-A885-1B1369D6634E}" type="datetimeFigureOut">
              <a:rPr lang="en-US" smtClean="0"/>
              <a:t>7/2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14575-F5D6-442C-A239-E66DAE4CFB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144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202071" y="1333500"/>
            <a:ext cx="6691710" cy="4195763"/>
            <a:chOff x="1202071" y="1333500"/>
            <a:chExt cx="6691710" cy="4195763"/>
          </a:xfrm>
        </p:grpSpPr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58754691"/>
                </p:ext>
              </p:extLst>
            </p:nvPr>
          </p:nvGraphicFramePr>
          <p:xfrm>
            <a:off x="3076359" y="1333500"/>
            <a:ext cx="4817422" cy="41957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01916263"/>
                </p:ext>
              </p:extLst>
            </p:nvPr>
          </p:nvGraphicFramePr>
          <p:xfrm>
            <a:off x="1202071" y="1828835"/>
            <a:ext cx="3446129" cy="36956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" name="Group 1"/>
            <p:cNvGrpSpPr/>
            <p:nvPr/>
          </p:nvGrpSpPr>
          <p:grpSpPr>
            <a:xfrm>
              <a:off x="2373975" y="1981198"/>
              <a:ext cx="2017296" cy="933485"/>
              <a:chOff x="1708604" y="1820014"/>
              <a:chExt cx="2413658" cy="1275966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1708604" y="1820014"/>
                <a:ext cx="457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600" b="1" smtClean="0"/>
                  <a:t>*</a:t>
                </a:r>
                <a:endParaRPr lang="en-US" sz="1600" b="1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2697406" y="2757426"/>
                <a:ext cx="457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600" b="1" smtClean="0"/>
                  <a:t>*</a:t>
                </a:r>
                <a:endParaRPr lang="en-US" sz="1600" b="1"/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665061" y="2028330"/>
                <a:ext cx="457201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l-PL" sz="1600" b="1" smtClean="0"/>
                  <a:t>*</a:t>
                </a:r>
                <a:endParaRPr lang="en-US" sz="1600" b="1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5293237" y="2133600"/>
              <a:ext cx="383663" cy="25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smtClean="0"/>
                <a:t>*</a:t>
              </a:r>
              <a:endParaRPr lang="en-US" sz="1600" b="1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254855" y="3166646"/>
              <a:ext cx="3836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smtClean="0"/>
                <a:t>*</a:t>
              </a:r>
              <a:endParaRPr lang="en-US" sz="1600" b="1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200898" y="2438400"/>
              <a:ext cx="383663" cy="254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smtClean="0"/>
                <a:t>*</a:t>
              </a:r>
              <a:endParaRPr lang="en-US" sz="1600" b="1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202072" y="1333500"/>
              <a:ext cx="6663134" cy="41910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6446687" y="6498193"/>
            <a:ext cx="2697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pl-PL" b="1" smtClean="0"/>
              <a:t>Supplementary figure 1</a:t>
            </a:r>
            <a:endParaRPr lang="en-US" b="1"/>
          </a:p>
        </p:txBody>
      </p:sp>
    </p:spTree>
    <p:extLst>
      <p:ext uri="{BB962C8B-B14F-4D97-AF65-F5344CB8AC3E}">
        <p14:creationId xmlns:p14="http://schemas.microsoft.com/office/powerpoint/2010/main" val="828504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3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buser</dc:creator>
  <cp:lastModifiedBy>Ratajczak,Mariusz</cp:lastModifiedBy>
  <cp:revision>13</cp:revision>
  <dcterms:created xsi:type="dcterms:W3CDTF">2016-05-28T17:22:22Z</dcterms:created>
  <dcterms:modified xsi:type="dcterms:W3CDTF">2016-07-27T16:59:00Z</dcterms:modified>
</cp:coreProperties>
</file>